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9" r:id="rId4"/>
    <p:sldId id="258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10" autoAdjust="0"/>
    <p:restoredTop sz="94660"/>
  </p:normalViewPr>
  <p:slideViewPr>
    <p:cSldViewPr snapToGrid="0">
      <p:cViewPr varScale="1">
        <p:scale>
          <a:sx n="63" d="100"/>
          <a:sy n="63" d="100"/>
        </p:scale>
        <p:origin x="324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E3AE922-7C17-42DC-BD1E-4FA74F6C057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483FC0D6-E7CB-476D-8318-D6EA5233319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C51FC04-652C-4088-9796-4B441D74E1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BEE02-A69B-48CE-B27D-3CE83F5FC6E1}" type="datetimeFigureOut">
              <a:rPr lang="zh-CN" altLang="en-US" smtClean="0"/>
              <a:t>2023/5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E76215D-D0D9-458F-8010-B895E130C1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EAA40EB-0588-4DA9-9B91-BFCFABEFCD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CF24F-0923-40EF-ADF8-E34BB77684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66296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B7668E1-004A-42C2-B6C7-6AD72C355B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D25F438-695B-4C1F-8645-04789AA4BBF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CD6B3F5-F2C6-4064-AFED-CB7A420AA6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BEE02-A69B-48CE-B27D-3CE83F5FC6E1}" type="datetimeFigureOut">
              <a:rPr lang="zh-CN" altLang="en-US" smtClean="0"/>
              <a:t>2023/5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DBFFB6F-FF52-4AEF-9EF3-0C33B7F645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09D3425-0C20-4A3C-AA77-0C4E5F91B2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CF24F-0923-40EF-ADF8-E34BB77684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524583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0FC5B3FC-E878-4FD1-A2AF-A116F5F8426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EAD7A5E-FBE3-4357-8F7F-6F72BC5DE44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3920A9E-549F-45ED-ABBB-937FAC9952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BEE02-A69B-48CE-B27D-3CE83F5FC6E1}" type="datetimeFigureOut">
              <a:rPr lang="zh-CN" altLang="en-US" smtClean="0"/>
              <a:t>2023/5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397F2D8-6206-464B-8787-7205BA2D14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C305C7D-0E3E-4035-B51C-1830E90943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CF24F-0923-40EF-ADF8-E34BB77684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035913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30827F1-B529-41AE-AF9D-39502C9092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7835F10-B85B-4853-ADA9-133FF755CA2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683DA9A-6B16-416B-B986-263A40838B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BEE02-A69B-48CE-B27D-3CE83F5FC6E1}" type="datetimeFigureOut">
              <a:rPr lang="zh-CN" altLang="en-US" smtClean="0"/>
              <a:t>2023/5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0948DA2-E9A5-4295-952E-7B520762EC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4DD75A8-6C6E-4EE7-88EA-6C6AC732B7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CF24F-0923-40EF-ADF8-E34BB77684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712776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28E76AD-D41F-4F1D-9780-7FB61FCC3F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D5C2251-0E65-45F3-A3A7-984FD966A1A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566E9E6-7136-4B31-BD8A-A9E6B65774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BEE02-A69B-48CE-B27D-3CE83F5FC6E1}" type="datetimeFigureOut">
              <a:rPr lang="zh-CN" altLang="en-US" smtClean="0"/>
              <a:t>2023/5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939A6B4-17F3-4A5B-9E09-7E798838FE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FDC6C2D-948B-4ABA-BCCD-27B229002E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CF24F-0923-40EF-ADF8-E34BB77684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955291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89449DE-4D6A-4898-9D61-A74DF257F6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E20EEFC-7FE4-47BA-BD53-B8C4CAC1C7C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D91C193-9646-4A13-B88B-8145836F7FA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4146E63-1BD9-4C64-BC48-440BD5F4E2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BEE02-A69B-48CE-B27D-3CE83F5FC6E1}" type="datetimeFigureOut">
              <a:rPr lang="zh-CN" altLang="en-US" smtClean="0"/>
              <a:t>2023/5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FABD875-3B73-4580-8D9F-376D6B7EC2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2612945-DC45-483A-9BF8-40EB7030D0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CF24F-0923-40EF-ADF8-E34BB77684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4306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8B303C7-5E59-4F98-8357-1475995DA3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BE68FF2-CE9C-49E9-8A7D-9D8D65CE66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06F033D-F945-4224-8DA8-FCC319D8AFD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0246909F-A872-4C07-A71B-9BC122DB029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B7FCD836-2DA1-49DB-8482-F53DC775565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5593DA2B-ECCF-4F99-AD6C-725AA06B05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BEE02-A69B-48CE-B27D-3CE83F5FC6E1}" type="datetimeFigureOut">
              <a:rPr lang="zh-CN" altLang="en-US" smtClean="0"/>
              <a:t>2023/5/16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9D75C853-D376-4E19-A770-0FD39D5B21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C376DD33-351C-455C-BE7F-04F389A635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CF24F-0923-40EF-ADF8-E34BB77684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28945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C76A85E-6EC8-455A-B812-6ED07F8AA4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FA9C8022-0114-4576-B467-EA2477274A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BEE02-A69B-48CE-B27D-3CE83F5FC6E1}" type="datetimeFigureOut">
              <a:rPr lang="zh-CN" altLang="en-US" smtClean="0"/>
              <a:t>2023/5/16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E8542D5D-3549-489B-9416-A1E1CD287C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76C71060-D2DD-43E3-87D9-47360D4754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CF24F-0923-40EF-ADF8-E34BB77684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688157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30B73CDD-B53D-4033-B968-81C1924556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BEE02-A69B-48CE-B27D-3CE83F5FC6E1}" type="datetimeFigureOut">
              <a:rPr lang="zh-CN" altLang="en-US" smtClean="0"/>
              <a:t>2023/5/16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986A9129-3CCE-4FAE-BBE0-C79C392EAB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183B38C9-E16D-4136-B0A0-E28EFF3156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CF24F-0923-40EF-ADF8-E34BB77684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86727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EE8EA3C-A220-4FB2-9827-798FE9C313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3642368-1A76-410B-AF7D-F0F0BFA5BEB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D5DA769-BE89-442A-B91A-FB60B3C5389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1BF965C-A22A-4799-96D9-9AD94B235F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BEE02-A69B-48CE-B27D-3CE83F5FC6E1}" type="datetimeFigureOut">
              <a:rPr lang="zh-CN" altLang="en-US" smtClean="0"/>
              <a:t>2023/5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08CCDF5-0AB6-43B2-A72A-BAAE1EA579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D8DF594-BC4D-4253-971C-7153A67214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CF24F-0923-40EF-ADF8-E34BB77684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649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FC66A12-BEE4-4A4F-B186-4A2EE214C2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AE48225B-C093-4AA5-B166-B1A702321D2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14E62E6-A1D2-4AB6-A35E-ADDB7BBE603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38841B8-AA60-4141-944A-0FFB46FCFA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BEE02-A69B-48CE-B27D-3CE83F5FC6E1}" type="datetimeFigureOut">
              <a:rPr lang="zh-CN" altLang="en-US" smtClean="0"/>
              <a:t>2023/5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F9FC882-2699-4F6B-92EA-E465B2D1F4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9C79FBF-DD8C-4D78-BAB9-455406EA12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CF24F-0923-40EF-ADF8-E34BB77684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921314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B1A291F5-8375-47B0-9E00-C7EAFD7B88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F481AF6-7532-4746-B0D0-C1B3FA1753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15D947F-C2E6-42B7-9C24-31DA86D25EC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CBEE02-A69B-48CE-B27D-3CE83F5FC6E1}" type="datetimeFigureOut">
              <a:rPr lang="zh-CN" altLang="en-US" smtClean="0"/>
              <a:t>2023/5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79BBC42-DE5D-43C0-A443-C2EE2D85FAF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85C3E56-5540-4115-B905-6005B569360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ACF24F-0923-40EF-ADF8-E34BB77684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63539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图片 7">
            <a:extLst>
              <a:ext uri="{FF2B5EF4-FFF2-40B4-BE49-F238E27FC236}">
                <a16:creationId xmlns:a16="http://schemas.microsoft.com/office/drawing/2014/main" id="{F9566F69-27E7-470F-A3AA-5D3D8852DE3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72640" y="785706"/>
            <a:ext cx="7315200" cy="4876800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8C04AD80-49AA-4FED-8A4D-918E06101CD7}"/>
              </a:ext>
            </a:extLst>
          </p:cNvPr>
          <p:cNvSpPr txBox="1"/>
          <p:nvPr/>
        </p:nvSpPr>
        <p:spPr>
          <a:xfrm>
            <a:off x="914400" y="5662506"/>
            <a:ext cx="10607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Supplementary figure 1. </a:t>
            </a:r>
            <a:r>
              <a:rPr lang="en-US" altLang="zh-CN" dirty="0"/>
              <a:t>Sensitivity Analysis of combined OR between CPFE patients and IPF.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6419042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AC2D9362-2F23-4470-8DC5-8137A7D888AB}"/>
              </a:ext>
            </a:extLst>
          </p:cNvPr>
          <p:cNvSpPr txBox="1"/>
          <p:nvPr/>
        </p:nvSpPr>
        <p:spPr>
          <a:xfrm>
            <a:off x="914400" y="6075670"/>
            <a:ext cx="10607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Supplementary figure 2. </a:t>
            </a:r>
            <a:r>
              <a:rPr lang="en-US" altLang="zh-CN" dirty="0"/>
              <a:t>Sensitivity Analysis of pooled SMD between CPFE patients and IPF.</a:t>
            </a:r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C226D573-B5B4-463D-9CC4-A775DBAF73A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91400" y="1198870"/>
            <a:ext cx="73152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893258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75B19182-E866-4729-8E79-AECCE2FEE96E}"/>
              </a:ext>
            </a:extLst>
          </p:cNvPr>
          <p:cNvSpPr txBox="1"/>
          <p:nvPr/>
        </p:nvSpPr>
        <p:spPr>
          <a:xfrm>
            <a:off x="914400" y="5648960"/>
            <a:ext cx="10607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Supplementary figure 3. </a:t>
            </a:r>
            <a:r>
              <a:rPr lang="en-US" altLang="zh-CN" dirty="0"/>
              <a:t>Sensitivity Analysis of combined OR between CPFE patients and emphysema.</a:t>
            </a:r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74D1B7F7-8342-4E43-B36B-C5BBC10B17B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46960" y="772160"/>
            <a:ext cx="73152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2843561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文本框 6">
            <a:extLst>
              <a:ext uri="{FF2B5EF4-FFF2-40B4-BE49-F238E27FC236}">
                <a16:creationId xmlns:a16="http://schemas.microsoft.com/office/drawing/2014/main" id="{A5A0580C-6946-45BE-9017-F1CC61B18871}"/>
              </a:ext>
            </a:extLst>
          </p:cNvPr>
          <p:cNvSpPr txBox="1"/>
          <p:nvPr/>
        </p:nvSpPr>
        <p:spPr>
          <a:xfrm>
            <a:off x="914400" y="5648960"/>
            <a:ext cx="10607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Supplementary figure 4. </a:t>
            </a:r>
            <a:r>
              <a:rPr lang="en-US" altLang="zh-CN" dirty="0"/>
              <a:t>Sensitivity Analysis of pooled SMD between CPFE patients and emphysema.</a:t>
            </a:r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96F29D36-00C2-4232-93EE-9192533C4AF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92108" y="772160"/>
            <a:ext cx="73152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030637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16</TotalTime>
  <Words>60</Words>
  <Application>Microsoft Office PowerPoint</Application>
  <PresentationFormat>宽屏</PresentationFormat>
  <Paragraphs>4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8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nihangqi</dc:creator>
  <cp:lastModifiedBy>杭琪 倪</cp:lastModifiedBy>
  <cp:revision>9</cp:revision>
  <dcterms:created xsi:type="dcterms:W3CDTF">2022-12-12T07:06:04Z</dcterms:created>
  <dcterms:modified xsi:type="dcterms:W3CDTF">2023-05-16T14:26:24Z</dcterms:modified>
</cp:coreProperties>
</file>